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428596" y="6072206"/>
            <a:ext cx="8358246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26: </a:t>
            </a:r>
            <a:r>
              <a:rPr lang="en-GB" sz="1600" dirty="0" smtClean="0"/>
              <a:t>3D model structure and validation of </a:t>
            </a:r>
            <a:r>
              <a:rPr lang="en-US" sz="1600" dirty="0" smtClean="0"/>
              <a:t>MET</a:t>
            </a:r>
            <a:r>
              <a:rPr lang="en-GB" sz="1600" dirty="0" smtClean="0"/>
              <a:t> gene. A) Wild (Template </a:t>
            </a:r>
            <a:r>
              <a:rPr lang="en-US" sz="1600" dirty="0"/>
              <a:t>3uoa_B</a:t>
            </a:r>
            <a:r>
              <a:rPr lang="en-US" sz="1600" dirty="0" smtClean="0"/>
              <a:t>)</a:t>
            </a:r>
            <a:r>
              <a:rPr lang="en-GB" sz="1600" dirty="0" smtClean="0"/>
              <a:t>, B) Mutant (Template </a:t>
            </a:r>
            <a:r>
              <a:rPr lang="en-US" sz="1600" dirty="0"/>
              <a:t>3uoa_B</a:t>
            </a:r>
            <a:r>
              <a:rPr lang="en-US" sz="1600" dirty="0" smtClean="0"/>
              <a:t>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761993" y="142852"/>
            <a:ext cx="2952751" cy="27860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214942" y="285728"/>
            <a:ext cx="3500462" cy="2643206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5125" name="Picture 5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785786" y="3214686"/>
            <a:ext cx="2928958" cy="26432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126" name="Picture 6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214942" y="3214686"/>
            <a:ext cx="3500462" cy="2665598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sp>
        <p:nvSpPr>
          <p:cNvPr id="20" name="Rectangle 19"/>
          <p:cNvSpPr/>
          <p:nvPr/>
        </p:nvSpPr>
        <p:spPr>
          <a:xfrm>
            <a:off x="4159515" y="3244334"/>
            <a:ext cx="82496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MALT1</a:t>
            </a:r>
            <a:endParaRPr lang="en-GB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2</Words>
  <Application>Microsoft Office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70</cp:revision>
  <dcterms:created xsi:type="dcterms:W3CDTF">2018-05-10T07:33:24Z</dcterms:created>
  <dcterms:modified xsi:type="dcterms:W3CDTF">2018-05-29T07:28:53Z</dcterms:modified>
</cp:coreProperties>
</file>